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255" autoAdjust="0"/>
  </p:normalViewPr>
  <p:slideViewPr>
    <p:cSldViewPr snapToGrid="0" snapToObjects="1" showGuides="1">
      <p:cViewPr>
        <p:scale>
          <a:sx n="100" d="100"/>
          <a:sy n="100" d="100"/>
        </p:scale>
        <p:origin x="-1144" y="-80"/>
      </p:cViewPr>
      <p:guideLst>
        <p:guide orient="horz" pos="1123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353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2779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620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7868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56123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19610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4754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10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4091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99066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0940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112D35-171E-9F41-A796-818DC40EA7ED}" type="datetimeFigureOut">
              <a:rPr kumimoji="1" lang="ja-JP" altLang="en-US" smtClean="0"/>
              <a:t>16/03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D70B9F-E139-5C46-A01F-A83B60A3978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9488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図形グループ 34"/>
          <p:cNvGrpSpPr/>
          <p:nvPr/>
        </p:nvGrpSpPr>
        <p:grpSpPr>
          <a:xfrm>
            <a:off x="129758" y="315305"/>
            <a:ext cx="6812422" cy="8255883"/>
            <a:chOff x="91658" y="531205"/>
            <a:chExt cx="6812422" cy="8255883"/>
          </a:xfrm>
        </p:grpSpPr>
        <p:grpSp>
          <p:nvGrpSpPr>
            <p:cNvPr id="27" name="図形グループ 26"/>
            <p:cNvGrpSpPr/>
            <p:nvPr/>
          </p:nvGrpSpPr>
          <p:grpSpPr>
            <a:xfrm>
              <a:off x="211183" y="777191"/>
              <a:ext cx="6692897" cy="3495665"/>
              <a:chOff x="119525" y="1188700"/>
              <a:chExt cx="6692897" cy="3495665"/>
            </a:xfrm>
          </p:grpSpPr>
          <p:sp>
            <p:nvSpPr>
              <p:cNvPr id="5" name="正方形/長方形 4"/>
              <p:cNvSpPr/>
              <p:nvPr/>
            </p:nvSpPr>
            <p:spPr>
              <a:xfrm>
                <a:off x="2013838" y="1647516"/>
                <a:ext cx="1949536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6" name="テキスト ボックス 5"/>
              <p:cNvSpPr txBox="1"/>
              <p:nvPr/>
            </p:nvSpPr>
            <p:spPr>
              <a:xfrm>
                <a:off x="119525" y="1511658"/>
                <a:ext cx="157415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fumigatus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A</a:t>
                </a:r>
                <a:endParaRPr kumimoji="1" lang="en-US" altLang="ja-JP" sz="1100" dirty="0" smtClean="0"/>
              </a:p>
              <a:p>
                <a:r>
                  <a:rPr kumimoji="1" lang="en-US" altLang="ja-JP" sz="1100" dirty="0" smtClean="0"/>
                  <a:t> (Afu3g09690) (177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.)</a:t>
                </a:r>
                <a:endParaRPr kumimoji="1" lang="ja-JP" altLang="en-US" sz="1100" dirty="0"/>
              </a:p>
            </p:txBody>
          </p:sp>
          <p:sp>
            <p:nvSpPr>
              <p:cNvPr id="7" name="正方形/長方形 6"/>
              <p:cNvSpPr/>
              <p:nvPr/>
            </p:nvSpPr>
            <p:spPr>
              <a:xfrm>
                <a:off x="2013838" y="1997032"/>
                <a:ext cx="1851292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8" name="テキスト ボックス 7"/>
              <p:cNvSpPr txBox="1"/>
              <p:nvPr/>
            </p:nvSpPr>
            <p:spPr>
              <a:xfrm>
                <a:off x="119525" y="1871591"/>
                <a:ext cx="157415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fumigatus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B</a:t>
                </a:r>
                <a:endParaRPr kumimoji="1" lang="en-US" altLang="ja-JP" sz="1100" dirty="0" smtClean="0"/>
              </a:p>
              <a:p>
                <a:r>
                  <a:rPr kumimoji="1" lang="en-US" altLang="ja-JP" sz="1100" dirty="0" smtClean="0"/>
                  <a:t> (Afu8g01710) (167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.)</a:t>
                </a:r>
                <a:endParaRPr kumimoji="1" lang="ja-JP" altLang="en-US" sz="1100" dirty="0"/>
              </a:p>
            </p:txBody>
          </p:sp>
          <p:sp>
            <p:nvSpPr>
              <p:cNvPr id="9" name="正方形/長方形 8"/>
              <p:cNvSpPr/>
              <p:nvPr/>
            </p:nvSpPr>
            <p:spPr>
              <a:xfrm>
                <a:off x="2013839" y="2358943"/>
                <a:ext cx="3674950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0" name="テキスト ボックス 9"/>
              <p:cNvSpPr txBox="1"/>
              <p:nvPr/>
            </p:nvSpPr>
            <p:spPr>
              <a:xfrm>
                <a:off x="119525" y="2251848"/>
                <a:ext cx="157415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fumigatus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C</a:t>
                </a:r>
                <a:r>
                  <a:rPr kumimoji="1" lang="en-US" altLang="ja-JP" sz="1100" dirty="0" smtClean="0"/>
                  <a:t> </a:t>
                </a:r>
              </a:p>
              <a:p>
                <a:r>
                  <a:rPr kumimoji="1" lang="en-US" altLang="ja-JP" sz="1100" dirty="0" smtClean="0"/>
                  <a:t> (Afu3g00510) (290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.)</a:t>
                </a:r>
                <a:endParaRPr kumimoji="1" lang="ja-JP" altLang="en-US" sz="1100" dirty="0"/>
              </a:p>
            </p:txBody>
          </p:sp>
          <p:sp>
            <p:nvSpPr>
              <p:cNvPr id="11" name="正方形/長方形 10"/>
              <p:cNvSpPr/>
              <p:nvPr/>
            </p:nvSpPr>
            <p:spPr>
              <a:xfrm>
                <a:off x="2013838" y="2877019"/>
                <a:ext cx="2265760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2" name="テキスト ボックス 11"/>
              <p:cNvSpPr txBox="1"/>
              <p:nvPr/>
            </p:nvSpPr>
            <p:spPr>
              <a:xfrm>
                <a:off x="119525" y="2741161"/>
                <a:ext cx="1912966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oryzae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A</a:t>
                </a:r>
                <a:endParaRPr kumimoji="1" lang="en-US" altLang="ja-JP" sz="1100" dirty="0" smtClean="0"/>
              </a:p>
              <a:p>
                <a:r>
                  <a:rPr kumimoji="1" lang="en-US" altLang="ja-JP" sz="1100" dirty="0" smtClean="0"/>
                  <a:t> (AO090005001280) (200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.)</a:t>
                </a:r>
                <a:endParaRPr kumimoji="1" lang="ja-JP" altLang="en-US" sz="1100" dirty="0"/>
              </a:p>
            </p:txBody>
          </p:sp>
          <p:sp>
            <p:nvSpPr>
              <p:cNvPr id="13" name="正方形/長方形 12"/>
              <p:cNvSpPr/>
              <p:nvPr/>
            </p:nvSpPr>
            <p:spPr>
              <a:xfrm>
                <a:off x="2013839" y="4004893"/>
                <a:ext cx="1949536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4" name="テキスト ボックス 13"/>
              <p:cNvSpPr txBox="1"/>
              <p:nvPr/>
            </p:nvSpPr>
            <p:spPr>
              <a:xfrm>
                <a:off x="119525" y="3878439"/>
                <a:ext cx="1303042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nidulans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A</a:t>
                </a:r>
                <a:r>
                  <a:rPr kumimoji="1" lang="en-US" altLang="ja-JP" sz="1100" dirty="0" smtClean="0"/>
                  <a:t> </a:t>
                </a:r>
              </a:p>
              <a:p>
                <a:r>
                  <a:rPr kumimoji="1" lang="en-US" altLang="ja-JP" sz="1100" dirty="0" smtClean="0"/>
                  <a:t> (AN7619) (171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)</a:t>
                </a:r>
                <a:endParaRPr kumimoji="1" lang="ja-JP" altLang="en-US" sz="1100" dirty="0"/>
              </a:p>
            </p:txBody>
          </p:sp>
          <p:sp>
            <p:nvSpPr>
              <p:cNvPr id="15" name="正方形/長方形 14"/>
              <p:cNvSpPr/>
              <p:nvPr/>
            </p:nvSpPr>
            <p:spPr>
              <a:xfrm>
                <a:off x="2013839" y="3408264"/>
                <a:ext cx="1949536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6" name="テキスト ボックス 15"/>
              <p:cNvSpPr txBox="1"/>
              <p:nvPr/>
            </p:nvSpPr>
            <p:spPr>
              <a:xfrm>
                <a:off x="119525" y="3285915"/>
                <a:ext cx="1603010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niger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alA</a:t>
                </a:r>
                <a:endParaRPr kumimoji="1" lang="en-US" altLang="ja-JP" sz="1100" dirty="0" smtClean="0"/>
              </a:p>
              <a:p>
                <a:r>
                  <a:rPr kumimoji="1" lang="en-US" altLang="ja-JP" sz="1100" dirty="0" smtClean="0"/>
                  <a:t> (An16g03330) (180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.)</a:t>
                </a:r>
                <a:endParaRPr kumimoji="1" lang="ja-JP" altLang="en-US" sz="1100" dirty="0"/>
              </a:p>
            </p:txBody>
          </p:sp>
          <p:sp>
            <p:nvSpPr>
              <p:cNvPr id="17" name="正方形/長方形 16"/>
              <p:cNvSpPr/>
              <p:nvPr/>
            </p:nvSpPr>
            <p:spPr>
              <a:xfrm>
                <a:off x="2013839" y="4379932"/>
                <a:ext cx="1949536" cy="119453"/>
              </a:xfrm>
              <a:prstGeom prst="rect">
                <a:avLst/>
              </a:prstGeom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rgbClr val="008000"/>
                </a:solidFill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100"/>
              </a:p>
            </p:txBody>
          </p:sp>
          <p:sp>
            <p:nvSpPr>
              <p:cNvPr id="18" name="テキスト ボックス 17"/>
              <p:cNvSpPr txBox="1"/>
              <p:nvPr/>
            </p:nvSpPr>
            <p:spPr>
              <a:xfrm>
                <a:off x="119525" y="4253478"/>
                <a:ext cx="1303042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 smtClean="0"/>
                  <a:t>A. </a:t>
                </a:r>
                <a:r>
                  <a:rPr kumimoji="1" lang="en-US" altLang="ja-JP" sz="1100" i="1" dirty="0" err="1" smtClean="0"/>
                  <a:t>nidulans</a:t>
                </a:r>
                <a:r>
                  <a:rPr kumimoji="1" lang="en-US" altLang="ja-JP" sz="1100" i="1" dirty="0" smtClean="0"/>
                  <a:t> </a:t>
                </a:r>
                <a:r>
                  <a:rPr kumimoji="1" lang="en-US" altLang="ja-JP" sz="1100" dirty="0" err="1" smtClean="0"/>
                  <a:t>CetA</a:t>
                </a:r>
                <a:r>
                  <a:rPr kumimoji="1" lang="en-US" altLang="ja-JP" sz="1100" dirty="0" smtClean="0"/>
                  <a:t> </a:t>
                </a:r>
              </a:p>
              <a:p>
                <a:r>
                  <a:rPr kumimoji="1" lang="en-US" altLang="ja-JP" sz="1100" dirty="0" smtClean="0"/>
                  <a:t> (AN3079) (176 </a:t>
                </a:r>
                <a:r>
                  <a:rPr kumimoji="1" lang="en-US" altLang="ja-JP" sz="1100" dirty="0" err="1" smtClean="0"/>
                  <a:t>a.a</a:t>
                </a:r>
                <a:r>
                  <a:rPr kumimoji="1" lang="en-US" altLang="ja-JP" sz="1100" dirty="0" smtClean="0"/>
                  <a:t>)</a:t>
                </a:r>
                <a:endParaRPr kumimoji="1" lang="ja-JP" altLang="en-US" sz="1100" dirty="0"/>
              </a:p>
            </p:txBody>
          </p:sp>
          <p:sp>
            <p:nvSpPr>
              <p:cNvPr id="19" name="テキスト ボックス 18"/>
              <p:cNvSpPr txBox="1"/>
              <p:nvPr/>
            </p:nvSpPr>
            <p:spPr>
              <a:xfrm>
                <a:off x="5506750" y="1188700"/>
                <a:ext cx="1305672" cy="4308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100" dirty="0" smtClean="0"/>
                  <a:t>Germination</a:t>
                </a:r>
              </a:p>
              <a:p>
                <a:pPr algn="ctr"/>
                <a:r>
                  <a:rPr kumimoji="1" lang="en-US" altLang="ja-JP" sz="1100" dirty="0" smtClean="0"/>
                  <a:t>Induced-expression</a:t>
                </a:r>
                <a:endParaRPr kumimoji="1" lang="ja-JP" altLang="en-US" sz="1100" dirty="0"/>
              </a:p>
            </p:txBody>
          </p:sp>
          <p:sp>
            <p:nvSpPr>
              <p:cNvPr id="20" name="テキスト ボックス 19"/>
              <p:cNvSpPr txBox="1"/>
              <p:nvPr/>
            </p:nvSpPr>
            <p:spPr>
              <a:xfrm>
                <a:off x="6053455" y="1548840"/>
                <a:ext cx="235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+</a:t>
                </a:r>
                <a:endParaRPr kumimoji="1" lang="ja-JP" altLang="en-US" sz="1100" b="1" dirty="0"/>
              </a:p>
            </p:txBody>
          </p:sp>
          <p:sp>
            <p:nvSpPr>
              <p:cNvPr id="21" name="テキスト ボックス 20"/>
              <p:cNvSpPr txBox="1"/>
              <p:nvPr/>
            </p:nvSpPr>
            <p:spPr>
              <a:xfrm>
                <a:off x="6062640" y="1883125"/>
                <a:ext cx="235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+</a:t>
                </a:r>
                <a:endParaRPr kumimoji="1" lang="ja-JP" altLang="en-US" sz="1100" b="1" dirty="0"/>
              </a:p>
            </p:txBody>
          </p:sp>
          <p:sp>
            <p:nvSpPr>
              <p:cNvPr id="22" name="テキスト ボックス 21"/>
              <p:cNvSpPr txBox="1"/>
              <p:nvPr/>
            </p:nvSpPr>
            <p:spPr>
              <a:xfrm>
                <a:off x="6062640" y="2735301"/>
                <a:ext cx="235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+</a:t>
                </a:r>
                <a:endParaRPr kumimoji="1" lang="ja-JP" altLang="en-US" sz="1100" b="1" dirty="0"/>
              </a:p>
            </p:txBody>
          </p:sp>
          <p:sp>
            <p:nvSpPr>
              <p:cNvPr id="23" name="テキスト ボックス 22"/>
              <p:cNvSpPr txBox="1"/>
              <p:nvPr/>
            </p:nvSpPr>
            <p:spPr>
              <a:xfrm>
                <a:off x="6062640" y="3308411"/>
                <a:ext cx="2358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+</a:t>
                </a:r>
                <a:endParaRPr kumimoji="1" lang="ja-JP" altLang="en-US" sz="1100" b="1" dirty="0"/>
              </a:p>
            </p:txBody>
          </p:sp>
          <p:sp>
            <p:nvSpPr>
              <p:cNvPr id="24" name="テキスト ボックス 23"/>
              <p:cNvSpPr txBox="1"/>
              <p:nvPr/>
            </p:nvSpPr>
            <p:spPr>
              <a:xfrm>
                <a:off x="6059783" y="2242250"/>
                <a:ext cx="25492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/>
                  <a:t>+</a:t>
                </a:r>
                <a:endParaRPr kumimoji="1" lang="ja-JP" altLang="en-US" sz="1100" b="1" dirty="0"/>
              </a:p>
            </p:txBody>
          </p:sp>
          <p:sp>
            <p:nvSpPr>
              <p:cNvPr id="25" name="テキスト ボックス 24"/>
              <p:cNvSpPr txBox="1"/>
              <p:nvPr/>
            </p:nvSpPr>
            <p:spPr>
              <a:xfrm>
                <a:off x="6062640" y="3895831"/>
                <a:ext cx="2313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?</a:t>
                </a:r>
                <a:endParaRPr kumimoji="1" lang="ja-JP" altLang="en-US" sz="1100" b="1" dirty="0"/>
              </a:p>
            </p:txBody>
          </p:sp>
          <p:sp>
            <p:nvSpPr>
              <p:cNvPr id="26" name="テキスト ボックス 25"/>
              <p:cNvSpPr txBox="1"/>
              <p:nvPr/>
            </p:nvSpPr>
            <p:spPr>
              <a:xfrm>
                <a:off x="6053455" y="4252863"/>
                <a:ext cx="2313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b="1" dirty="0" smtClean="0"/>
                  <a:t>?</a:t>
                </a:r>
                <a:endParaRPr kumimoji="1" lang="ja-JP" altLang="en-US" sz="1100" b="1" dirty="0"/>
              </a:p>
            </p:txBody>
          </p:sp>
        </p:grpSp>
        <p:sp>
          <p:nvSpPr>
            <p:cNvPr id="28" name="テキスト ボックス 27"/>
            <p:cNvSpPr txBox="1"/>
            <p:nvPr/>
          </p:nvSpPr>
          <p:spPr>
            <a:xfrm>
              <a:off x="91658" y="531205"/>
              <a:ext cx="3257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/>
                <a:t>A</a:t>
              </a:r>
              <a:endParaRPr kumimoji="1" lang="ja-JP" altLang="en-US" b="1" dirty="0"/>
            </a:p>
          </p:txBody>
        </p:sp>
        <p:pic>
          <p:nvPicPr>
            <p:cNvPr id="29" name="図 2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055032" y="4735576"/>
              <a:ext cx="2571856" cy="3960645"/>
            </a:xfrm>
            <a:prstGeom prst="rect">
              <a:avLst/>
            </a:prstGeom>
          </p:spPr>
        </p:pic>
        <p:sp>
          <p:nvSpPr>
            <p:cNvPr id="30" name="テキスト ボックス 29"/>
            <p:cNvSpPr txBox="1"/>
            <p:nvPr/>
          </p:nvSpPr>
          <p:spPr>
            <a:xfrm>
              <a:off x="91658" y="4396072"/>
              <a:ext cx="33909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b="1" dirty="0" smtClean="0"/>
                <a:t>B</a:t>
              </a:r>
              <a:endParaRPr kumimoji="1" lang="ja-JP" altLang="en-US" b="1" dirty="0"/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263930" y="4632104"/>
              <a:ext cx="3557384" cy="415498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ja-JP" altLang="en-US" sz="600" dirty="0">
                <a:latin typeface="Osaka−等幅"/>
                <a:ea typeface="Osaka−等幅"/>
                <a:cs typeface="Osaka−等幅"/>
              </a:endParaRP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o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MMFTKTI-TLAALASLAAALP---TANPVKR----------------------------- 27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n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MFFKTI-LTAALATAATALPHSVNNNMVRRNGT-----------------------SSG 35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MMFTKAF-FAAAFATLSTALPH-----VIQRSGN-----------------------SSA 31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etA_A._nidulans_      MMFTKAL-VAATLATLTAALPQP---TVVRREGG-----------------------D-- 31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B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MSFSKFFSLAAAFALTASALPLAP----------------------------------RA 26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alA_A._nidulans_      MLFNKIISLAATLA-TASALPFAPA--------------------------------PRS 27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C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MFFSRLL-FIAAFALAVSALPQFYPGGSMTRHDATPTSSTSISPTSTFASSSASPSATTS 59</a:t>
              </a:r>
            </a:p>
            <a:p>
              <a:r>
                <a:rPr lang="ja-JP" altLang="en-US" sz="600" dirty="0">
                  <a:latin typeface="Osaka−等幅"/>
                  <a:ea typeface="Osaka−等幅"/>
                  <a:cs typeface="Osaka−等幅"/>
                </a:rPr>
                <a:t>                         * 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: :   *::*   :***                                       </a:t>
              </a:r>
            </a:p>
            <a:p>
              <a:endParaRPr lang="ja-JP" altLang="en-US" sz="600" dirty="0">
                <a:latin typeface="Osaka−等幅"/>
                <a:ea typeface="Osaka−等幅"/>
                <a:cs typeface="Osaka−等幅"/>
              </a:endParaRP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o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SGGVNIVNNLG-ETVYAWSVSDRVSNMHTLSANGGNYQESWQTNDNGGGISIKLSNTQE 85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n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SGGVSISNNMSNTTVYAWSVSDRVSNMHTLSAGGGSYSESWQTNDNGGGISIKLSTTES 94</a:t>
              </a:r>
            </a:p>
            <a:p>
              <a:r>
                <a:rPr lang="hr-HR" altLang="ja-JP" sz="600" dirty="0">
                  <a:latin typeface="Osaka−等幅"/>
                  <a:ea typeface="Osaka−等幅"/>
                  <a:cs typeface="Osaka−等幅"/>
                </a:rPr>
                <a:t>AfCalA                 SGGGVQIVNNLS-QTVYAWSVADSVSDMHTLSADGGSYSEDWRTNSNGGGVSIKLSTKPD 90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etA_A._nidulans_      --AGVTIVNNMD-SDVYAWSVTDGVSKMHTLSSGGGSYTENFQANPNGGGVSIKLSTHQD 88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B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PSGGVQIVNNMG-ENVYLWSVSDTSSDMQTIQP-GSSYVETWRTNPNGGGVSIKISTAAD 84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alA_A._nidulans_      ISGGVTLINNLS-QDLYLWSVSGTASPMVTLPA-GQSYQETWQINPTGGGISIKIGCSED 85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C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SSGSVQIVNKLD-TTVYLWSTSDTSSAMQTIAS-GETYTETYRTNSNGGGISIKMATTES 117</a:t>
              </a:r>
            </a:p>
            <a:p>
              <a:r>
                <a:rPr lang="ja-JP" altLang="en-US" sz="600" dirty="0">
                  <a:latin typeface="Osaka−等幅"/>
                  <a:ea typeface="Osaka−等幅"/>
                  <a:cs typeface="Osaka−等幅"/>
                </a:rPr>
                <a:t>                         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..* : *::.   :* **.:.  * * *: . * .* * :: * .***:***:.   .</a:t>
              </a:r>
            </a:p>
            <a:p>
              <a:endParaRPr lang="ja-JP" altLang="en-US" sz="600" dirty="0">
                <a:latin typeface="Osaka−等幅"/>
                <a:ea typeface="Osaka−等幅"/>
                <a:cs typeface="Osaka−等幅"/>
              </a:endParaRP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o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QSNVLQFEYTQSGDTIYWDMSCIDLS-GDNVFTKYGFSVTPSSTSDNCPSVNCAAGDTAC 144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n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QSDVLQFEYTQDGDTIYWDMSCINLG-SDSAFTKYGFSVTPSEEGDNCPSVNCEAGDTAC 153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QSDVLQFEYTQSGDTIYWDMSCIDMG-TDSEFSKFGFTVEPSQSGGDCPSVNCKAGDTAC 149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etA_A._nidulans_      QTDVLQFEYTKSGETIFWDMSCIDMDRAASTFTKNGFDVSPSQTSGDCPAVNCHAGDTSC 148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B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LASVLQFEYTEAGETLFWDLSSINLS-PDSPLIAAGFGVSIDDAS--CPTASCAPGDVNC 141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alA_A._nidulans_      GSDVLQYEYTKVGDLLFWDMSSIDLS-SGSPLVAAGFDVSIDDSS--CDTVTCAPGDVNC 142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C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QASVLQFEYTKASDTLYWDLSAIDMD-SDSEFITAGFSATPSDAS--CSSVTCAAGESDC 174</a:t>
              </a:r>
            </a:p>
            <a:p>
              <a:r>
                <a:rPr lang="ja-JP" altLang="en-US" sz="600" dirty="0">
                  <a:latin typeface="Osaka−等幅"/>
                  <a:ea typeface="Osaka−等幅"/>
                  <a:cs typeface="Osaka−等幅"/>
                </a:rPr>
                <a:t>                        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:.***:***: .: ::**:*.*::.   . :   ** .  .. .  * :..* .*:  *</a:t>
              </a:r>
            </a:p>
            <a:p>
              <a:endParaRPr lang="ja-JP" altLang="en-US" sz="600" dirty="0">
                <a:latin typeface="Osaka−等幅"/>
                <a:ea typeface="Osaka−等幅"/>
                <a:cs typeface="Osaka−等幅"/>
              </a:endParaRP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o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AEAYLKPNDDHATHGCPIDTSFSSELNPLRLVNMIPTTNMGNGVRYGSGETGKGKN---- 200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n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AEAYLQPDDNEATHGCPIDTQFTLTLG--------------------------------- 180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AEAYLQPKDDHATHGCPINTSFVVNIGN-------------------------------- 177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etA_A._nidulans_      AEAYLQPKDDHATHGCPIDTSFTLTLGA-------------------------------- 176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B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AESYQFP-DDHNTRACGTGAAFTLTLG--------------------------------- 167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alA_A._nidulans_      SESYQYP-DDHNTRACSSSAAYTLTLGTAN------------------------------ 171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C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SEVYQES-DDVATQSCSATAGITTAVRPPRLSEGLPNMSYCKDQSTVAICHISVFLSVLI 233</a:t>
              </a:r>
            </a:p>
            <a:p>
              <a:r>
                <a:rPr lang="ja-JP" altLang="en-US" sz="600" dirty="0">
                  <a:latin typeface="Osaka−等幅"/>
                  <a:ea typeface="Osaka−等幅"/>
                  <a:cs typeface="Osaka−等幅"/>
                </a:rPr>
                <a:t>                       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:* *  . *:  *:.*   :     :                                  </a:t>
              </a:r>
            </a:p>
            <a:p>
              <a:endParaRPr lang="ja-JP" altLang="en-US" sz="600" dirty="0">
                <a:latin typeface="Osaka−等幅"/>
                <a:ea typeface="Osaka−等幅"/>
                <a:cs typeface="Osaka−等幅"/>
              </a:endParaRP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o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--------------------------------------------------------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n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--------------------------------------------------------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A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--------------------------------------------------------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etA_A._nidulans_      ---------------------------------------------------------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B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---------------------------------------------------------</a:t>
              </a:r>
            </a:p>
            <a:p>
              <a:r>
                <a:rPr lang="ro-RO" altLang="ja-JP" sz="600" dirty="0">
                  <a:latin typeface="Osaka−等幅"/>
                  <a:ea typeface="Osaka−等幅"/>
                  <a:cs typeface="Osaka−等幅"/>
                </a:rPr>
                <a:t>CalA_A._nidulans_      ---------------------------------------------------------</a:t>
              </a:r>
            </a:p>
            <a:p>
              <a:r>
                <a:rPr lang="en-US" altLang="ja-JP" sz="600" dirty="0" err="1">
                  <a:latin typeface="Osaka−等幅"/>
                  <a:ea typeface="Osaka−等幅"/>
                  <a:cs typeface="Osaka−等幅"/>
                </a:rPr>
                <a:t>AfCalC</a:t>
              </a:r>
              <a:r>
                <a:rPr lang="en-US" altLang="ja-JP" sz="600" dirty="0">
                  <a:latin typeface="Osaka−等幅"/>
                  <a:ea typeface="Osaka−等幅"/>
                  <a:cs typeface="Osaka−等幅"/>
                </a:rPr>
                <a:t>                 LYIEHNVAATVLEAAVVVLACSRDVVYERATITIACPGTLTVAAPPLSDTVVPLTLL 290</a:t>
              </a:r>
              <a:endParaRPr kumimoji="1" lang="ja-JP" altLang="en-US" sz="600" dirty="0">
                <a:latin typeface="Osaka−等幅"/>
                <a:ea typeface="Osaka−等幅"/>
                <a:cs typeface="Osaka−等幅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3897514" y="4396072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b="1" dirty="0" smtClean="0"/>
                <a:t>C</a:t>
              </a:r>
              <a:endParaRPr kumimoji="1" lang="ja-JP" altLang="en-US" b="1" dirty="0"/>
            </a:p>
          </p:txBody>
        </p:sp>
      </p:grpSp>
      <p:sp>
        <p:nvSpPr>
          <p:cNvPr id="34" name="テキスト ボックス 33"/>
          <p:cNvSpPr txBox="1"/>
          <p:nvPr/>
        </p:nvSpPr>
        <p:spPr>
          <a:xfrm>
            <a:off x="129758" y="8657861"/>
            <a:ext cx="2239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Fig. S2 Hagiwara et al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5925851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081</Words>
  <Application>Microsoft Macintosh PowerPoint</Application>
  <PresentationFormat>画面に合わせる (4:3)</PresentationFormat>
  <Paragraphs>7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千葉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萩原 大祐</dc:creator>
  <cp:lastModifiedBy>萩原 大祐</cp:lastModifiedBy>
  <cp:revision>5</cp:revision>
  <dcterms:created xsi:type="dcterms:W3CDTF">2015-05-20T02:34:11Z</dcterms:created>
  <dcterms:modified xsi:type="dcterms:W3CDTF">2016-03-11T08:54:18Z</dcterms:modified>
</cp:coreProperties>
</file>